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4" r:id="rId4"/>
    <p:sldId id="280" r:id="rId5"/>
    <p:sldId id="259" r:id="rId6"/>
    <p:sldId id="258" r:id="rId7"/>
    <p:sldId id="281" r:id="rId8"/>
    <p:sldId id="28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0959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126" y="3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200" d="100"/>
        <a:sy n="200" d="100"/>
      </p:scale>
      <p:origin x="0" y="-377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DE4EA8-9AC8-46AB-BA52-6A45D2D234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DD02E25-923C-4B43-8DC4-E27FD64C16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D34A51-4060-4B5C-B828-DC7943827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6361DD-AD42-40EB-B9FB-8E05C7B9A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B952A2-ED64-4C24-A3F3-EF8BD8364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150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AE27D7-CC15-45C9-A5C5-ACCA2DB42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4D239DC-84FF-45C9-85EC-C457E50B8A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7CA474-DAB7-4AEC-8E00-6872A2263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9AD6A7-223F-4CDA-B729-3E6B9A4D6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205A12-C1C0-4140-80C2-FFA500814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129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6D2B9D2-3830-48FE-BDDB-0015D9BD10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713C33-91BB-412C-A0CC-E4A9EE1C8D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B465E9-4BF3-43CD-8FAE-EA77080DB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85F1E9-2B92-4474-893F-91064285F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D3FF8E-86BA-4DEF-8916-17E2F1369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091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5DC65A-DA94-4971-910E-CDDD453BE0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6DFECC-1BD0-48DB-91AE-95DBD5F2A2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82B036-2B4C-4C98-9BCF-7712C07C5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A26C69-FC6B-4C0A-BEFF-AA76EF15E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2F7C89-B786-469E-B25E-4621BD879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11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28D534-5EB5-4EFA-B1D1-6E4B791924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F9CB89-EC8F-4B82-B7F6-A7EA84766D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18B3BF-4374-4ADE-9436-5D051E8E2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3BB0DE-BCB6-4969-98E1-E9A9D2367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FA1FD9-63EC-45F1-B942-033F2222C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046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44F025-1EA3-47D9-B3F1-95E6C1419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E0CEFB-88D8-40D9-BC77-053FAA3C8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3C3CEFB-17A6-4B52-AFDC-488426E1E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B22CC6-82CE-4C1C-A38D-C312BC462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C7AEB57-3C74-4514-95C4-A9C729834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DC81BA-503F-4D26-B4FA-4A4A8B6A2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5079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679E7F-668E-4CF3-9AE0-FD73272D2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1C077A-7743-452B-9F0F-1C1A312B92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3FB098-E890-4C54-A298-02B52390D1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D3CB55C-E9DB-4BFD-8B3C-D44CF21B48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F108612-353E-4C25-B554-BF9B1601B2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A84D2CD-3A9A-405F-B1A2-B904669F1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1CCDBF6-6814-4E31-B721-63CDF2B2C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C44FF2-C40C-4CA1-85B8-411B1C022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664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55034F-FB21-48C9-8FD7-F0DF67824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3E71794-9904-4E53-870D-749BE39F2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F31806E-C588-4B7E-B203-3195EDC7B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D1F0BE-A063-44E4-B9E9-8905D94F5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541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D43D9B5-C620-4F9A-8641-2FB4DD99A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86593B9-99E8-4098-805B-D5FD61117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2F8201-EE51-43ED-8F73-0C917E2EA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3006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665A8C-91F1-4472-A1A0-A188B02B70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36709C7-6C23-4347-BDC7-CE15DAD0F7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9BD4C9-C49A-43EC-B8F3-221295A737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8D2DB8-79E9-48C4-AAA9-354308E50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93137B-A5AC-477B-9D05-CBC58DEC2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ED2095-4686-4A1F-8742-62811364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590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6F6536-82CF-410D-A14D-3C4D3680A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33C3F83-30C0-43A3-8354-E24BA3D800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8F4C86A-D1F8-4C33-B870-3988CAF538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E85FA-61B2-4957-8F6D-D5C843CA9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C85178-23EF-4B18-8E3E-B18FDB928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B13022-2EA8-4D0E-B41C-FF7EB0D1E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492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C93F38F-A23B-45C6-B541-F68C35C32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3A28FCE-CED8-4B03-8BAF-80FA4B65C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BBEEC5-B8E1-4E1E-AE4F-30B94C57A2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F8A72-767E-47BA-964B-9A1380242B82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4585E6-EC36-455E-B028-7CA96426EC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DAEEF5-7B81-4D79-931B-E76C8CB563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E90AF-BA36-434D-887D-CE361828CC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779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.png"/><Relationship Id="rId7" Type="http://schemas.openxmlformats.org/officeDocument/2006/relationships/image" Target="../media/image1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png"/><Relationship Id="rId11" Type="http://schemas.openxmlformats.org/officeDocument/2006/relationships/image" Target="../media/image26.emf"/><Relationship Id="rId5" Type="http://schemas.openxmlformats.org/officeDocument/2006/relationships/image" Target="../media/image11.png"/><Relationship Id="rId10" Type="http://schemas.openxmlformats.org/officeDocument/2006/relationships/oleObject" Target="../embeddings/oleObject1.bin"/><Relationship Id="rId4" Type="http://schemas.openxmlformats.org/officeDocument/2006/relationships/image" Target="../media/image6.png"/><Relationship Id="rId9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1D44A48-E611-45A1-A510-CFDD27BA59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125" y="293687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6895F50-FE71-4B5E-AD5F-8042EA72DE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98875" y="293686"/>
            <a:ext cx="3333750" cy="36290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6C67EC5-EFD3-4501-9241-36589ECE7D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43725" y="293686"/>
            <a:ext cx="3333750" cy="362902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50BF1B21-154E-44A7-906A-39158C2547DF}"/>
              </a:ext>
            </a:extLst>
          </p:cNvPr>
          <p:cNvSpPr txBox="1"/>
          <p:nvPr/>
        </p:nvSpPr>
        <p:spPr>
          <a:xfrm>
            <a:off x="1231900" y="5301734"/>
            <a:ext cx="7239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楷体" panose="02010609060101010101" pitchFamily="49" charset="-122"/>
              </a:rPr>
              <a:t>N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67869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56C6F8-BA80-4826-BC01-1318BF49F7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097" y="0"/>
            <a:ext cx="3333750" cy="36290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E146B16-577F-4BB0-B734-ECBAD01366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1754" y="-54429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60F2E3A-E84F-4531-AF95-63560CAA45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67411" y="-54430"/>
            <a:ext cx="3333750" cy="362902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7302B586-7C42-4FA0-BED0-8E0AB35D7F18}"/>
              </a:ext>
            </a:extLst>
          </p:cNvPr>
          <p:cNvSpPr txBox="1"/>
          <p:nvPr/>
        </p:nvSpPr>
        <p:spPr>
          <a:xfrm>
            <a:off x="1279072" y="4539734"/>
            <a:ext cx="7239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HO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96632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0975C21-1155-4322-AEEC-F4F1A745D5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3687"/>
            <a:ext cx="3333750" cy="36290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D9828E4-4E80-490D-98B6-5DEFA54009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1239" y="293687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C16CD2B-7316-4D18-8C55-20376D02F5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2478" y="293686"/>
            <a:ext cx="3333750" cy="36290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450E4EB-FA5E-454C-89F7-F49828482D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63717" y="355597"/>
            <a:ext cx="3333750" cy="362902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8A5D56B-67B7-44B8-8362-B4DC8F6FFB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3228975"/>
            <a:ext cx="3333750" cy="362902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DCF3A76-4B60-4CE1-9FE6-181B6D862B4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46399" y="3429000"/>
            <a:ext cx="3333750" cy="362902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C812CB8-1F4B-4775-A8BA-7BF38FB96DD8}"/>
              </a:ext>
            </a:extLst>
          </p:cNvPr>
          <p:cNvSpPr txBox="1"/>
          <p:nvPr/>
        </p:nvSpPr>
        <p:spPr>
          <a:xfrm>
            <a:off x="8339817" y="5847834"/>
            <a:ext cx="7239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H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636561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0CDC267-8E7C-4A42-84E7-62AABDE8DD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239" y="134029"/>
            <a:ext cx="3333750" cy="36290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C03B08F-C86B-4C7D-AF75-934C3F0011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4725" y="134029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6DC7A42-349B-491E-B80B-99F2989F46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48475" y="134029"/>
            <a:ext cx="3333750" cy="362902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CFCD47E-380E-4BD4-8CAC-A3151D15B4BF}"/>
              </a:ext>
            </a:extLst>
          </p:cNvPr>
          <p:cNvSpPr txBox="1"/>
          <p:nvPr/>
        </p:nvSpPr>
        <p:spPr>
          <a:xfrm>
            <a:off x="8339816" y="5847834"/>
            <a:ext cx="1223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HG+YC-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1425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26AF279-9AB2-40C3-BFDB-2C52783D0D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3333750" cy="36290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4D90E47-DE5F-46F1-B919-8794D9FFF6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4782" y="-1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89BFFBA-8BD5-4D13-8B52-C27AC62564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5674" y="0"/>
            <a:ext cx="3333750" cy="36290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94AB31F-C0BD-4415-AD1D-D3C282CF33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906258"/>
            <a:ext cx="3333750" cy="362902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C85903E2-1B4A-443F-A513-BFB97B9F37F7}"/>
              </a:ext>
            </a:extLst>
          </p:cNvPr>
          <p:cNvSpPr txBox="1"/>
          <p:nvPr/>
        </p:nvSpPr>
        <p:spPr>
          <a:xfrm>
            <a:off x="8339816" y="5847834"/>
            <a:ext cx="1223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NG+NA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017598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A70603E-CF23-4DEF-A058-BECD78CCFF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5630"/>
            <a:ext cx="3333750" cy="36290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1FC9567-86A8-49EE-AA8C-70E0F77077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24440" y="90941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33DF57C-BDEF-4028-8464-4FB8B22F1C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94954" y="235630"/>
            <a:ext cx="3333750" cy="362902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908843D-025D-40C8-9A78-ECBCE2A5EAA6}"/>
              </a:ext>
            </a:extLst>
          </p:cNvPr>
          <p:cNvSpPr txBox="1"/>
          <p:nvPr/>
        </p:nvSpPr>
        <p:spPr>
          <a:xfrm>
            <a:off x="8339816" y="5847834"/>
            <a:ext cx="12232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HG+NA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633073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33D13EC-54D6-448D-BA5A-B57FF7CC9D17}"/>
              </a:ext>
            </a:extLst>
          </p:cNvPr>
          <p:cNvSpPr txBox="1"/>
          <p:nvPr/>
        </p:nvSpPr>
        <p:spPr>
          <a:xfrm>
            <a:off x="8339816" y="5847834"/>
            <a:ext cx="30266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HG+NAC+YC-1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EC86870-C8BA-4C3D-8D94-0539C3F110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37230"/>
            <a:ext cx="3333750" cy="362902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EBF4FC3-45EB-44CE-A290-5FC589208C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9925" y="312056"/>
            <a:ext cx="3333750" cy="36290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7D0D243-E533-44A9-9166-24653C9C4F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3675" y="268514"/>
            <a:ext cx="3333750" cy="3629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4475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1AD9814-B7CE-482F-86DD-50B71F0094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718" y="885705"/>
            <a:ext cx="1800000" cy="195942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32089ED-24C9-4BBD-9E61-A6EB96EE74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0362" y="885705"/>
            <a:ext cx="1800000" cy="195942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2A3B1EA-93BC-48C6-89AE-65D027B4BA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3682" y="885705"/>
            <a:ext cx="1800000" cy="195942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9947600-2979-4DD1-B1DD-A3AFE4FD2B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78787" y="885705"/>
            <a:ext cx="1800000" cy="195942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3C2350D-C55F-4AA2-B271-69E7ED0D7EB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75946" y="885705"/>
            <a:ext cx="1800000" cy="195942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B2BEEF7-E7EB-4F8C-A796-E5F330B2400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06412" y="885705"/>
            <a:ext cx="1800000" cy="195942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610022C-B74C-43EE-9F7E-C379003BBD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28500" y="885705"/>
            <a:ext cx="1800000" cy="1959429"/>
          </a:xfrm>
          <a:prstGeom prst="rect">
            <a:avLst/>
          </a:prstGeom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F8BAAFE2-DC67-428D-A5D4-6937EE0B4F02}"/>
              </a:ext>
            </a:extLst>
          </p:cNvPr>
          <p:cNvCxnSpPr>
            <a:endCxn id="11" idx="2"/>
          </p:cNvCxnSpPr>
          <p:nvPr/>
        </p:nvCxnSpPr>
        <p:spPr>
          <a:xfrm>
            <a:off x="698500" y="2845134"/>
            <a:ext cx="1053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031D7029-8726-46E8-94DC-EA9BBA1FF9EE}"/>
              </a:ext>
            </a:extLst>
          </p:cNvPr>
          <p:cNvCxnSpPr/>
          <p:nvPr/>
        </p:nvCxnSpPr>
        <p:spPr>
          <a:xfrm flipV="1">
            <a:off x="405718" y="1323975"/>
            <a:ext cx="0" cy="1333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58133F3C-FBEA-491A-A2B1-1C2CE3341C8F}"/>
              </a:ext>
            </a:extLst>
          </p:cNvPr>
          <p:cNvSpPr txBox="1"/>
          <p:nvPr/>
        </p:nvSpPr>
        <p:spPr>
          <a:xfrm>
            <a:off x="2628900" y="2924175"/>
            <a:ext cx="18383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DF853E9-6F69-4BDA-BA6F-FE6992118C25}"/>
              </a:ext>
            </a:extLst>
          </p:cNvPr>
          <p:cNvSpPr txBox="1"/>
          <p:nvPr/>
        </p:nvSpPr>
        <p:spPr>
          <a:xfrm rot="16200000">
            <a:off x="-2380" y="1821447"/>
            <a:ext cx="5047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69BBCF2-D550-4342-9649-367FF6A7208F}"/>
              </a:ext>
            </a:extLst>
          </p:cNvPr>
          <p:cNvSpPr txBox="1"/>
          <p:nvPr/>
        </p:nvSpPr>
        <p:spPr>
          <a:xfrm>
            <a:off x="1119869" y="751838"/>
            <a:ext cx="7239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kern="100" dirty="0">
                <a:effectLst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N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E503C6B-3C73-43A5-AD85-04484C29C8FD}"/>
              </a:ext>
            </a:extLst>
          </p:cNvPr>
          <p:cNvSpPr txBox="1"/>
          <p:nvPr/>
        </p:nvSpPr>
        <p:spPr>
          <a:xfrm>
            <a:off x="2638202" y="751838"/>
            <a:ext cx="7239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O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0C236F9-C805-4545-9D53-CD9001FD96D5}"/>
              </a:ext>
            </a:extLst>
          </p:cNvPr>
          <p:cNvSpPr txBox="1"/>
          <p:nvPr/>
        </p:nvSpPr>
        <p:spPr>
          <a:xfrm>
            <a:off x="4378101" y="751838"/>
            <a:ext cx="7239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73A79E8-F02A-4118-AACA-2BD670098079}"/>
              </a:ext>
            </a:extLst>
          </p:cNvPr>
          <p:cNvSpPr txBox="1"/>
          <p:nvPr/>
        </p:nvSpPr>
        <p:spPr>
          <a:xfrm>
            <a:off x="5852663" y="751838"/>
            <a:ext cx="122328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G+YC-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95991BC-944B-4E98-AF29-F1CEB83BC2F3}"/>
              </a:ext>
            </a:extLst>
          </p:cNvPr>
          <p:cNvSpPr txBox="1"/>
          <p:nvPr/>
        </p:nvSpPr>
        <p:spPr>
          <a:xfrm>
            <a:off x="7652663" y="751838"/>
            <a:ext cx="122328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NG+NA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BAE5414-D1D7-4D24-AEAB-7EC867B9199E}"/>
              </a:ext>
            </a:extLst>
          </p:cNvPr>
          <p:cNvSpPr txBox="1"/>
          <p:nvPr/>
        </p:nvSpPr>
        <p:spPr>
          <a:xfrm>
            <a:off x="9180288" y="751838"/>
            <a:ext cx="122328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G+NA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D41391C-669F-4A22-827C-A8EBB172C4FC}"/>
              </a:ext>
            </a:extLst>
          </p:cNvPr>
          <p:cNvSpPr txBox="1"/>
          <p:nvPr/>
        </p:nvSpPr>
        <p:spPr>
          <a:xfrm>
            <a:off x="10606771" y="751838"/>
            <a:ext cx="198868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G+NAC+YC-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518D5C08-C859-4271-A6F0-CD100605C1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2695904"/>
              </p:ext>
            </p:extLst>
          </p:nvPr>
        </p:nvGraphicFramePr>
        <p:xfrm>
          <a:off x="491218" y="3391535"/>
          <a:ext cx="3364820" cy="38661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10" imgW="2994168" imgH="3439471" progId="Prism9.Document">
                  <p:embed/>
                </p:oleObj>
              </mc:Choice>
              <mc:Fallback>
                <p:oleObj name="Prism 9" r:id="rId10" imgW="2994168" imgH="343947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91218" y="3391535"/>
                        <a:ext cx="3364820" cy="38661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68338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37</Words>
  <Application>Microsoft Office PowerPoint</Application>
  <PresentationFormat>宽屏</PresentationFormat>
  <Paragraphs>16</Paragraphs>
  <Slides>8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jun</dc:creator>
  <cp:lastModifiedBy>Yanjun</cp:lastModifiedBy>
  <cp:revision>10</cp:revision>
  <dcterms:created xsi:type="dcterms:W3CDTF">2021-05-13T04:40:10Z</dcterms:created>
  <dcterms:modified xsi:type="dcterms:W3CDTF">2021-10-18T10:22:54Z</dcterms:modified>
</cp:coreProperties>
</file>